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65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6" r:id="rId12"/>
    <p:sldId id="267" r:id="rId13"/>
    <p:sldId id="269" r:id="rId1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98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225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058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5057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398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4153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1172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1640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4170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67274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45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0450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3C4AF-3BDF-4254-AADB-5DF3D2FF2DB7}" type="datetimeFigureOut">
              <a:rPr lang="ko-KR" altLang="en-US" smtClean="0"/>
              <a:t>2026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D08E-7F2B-4DDB-BAE9-008F74E5C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9058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2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1700808"/>
            <a:ext cx="5004400" cy="1903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42424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3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856" y="620688"/>
            <a:ext cx="5988962" cy="6048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84753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067944" y="96898"/>
            <a:ext cx="89317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AC-CO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984" y="1429512"/>
            <a:ext cx="5590032" cy="3998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59891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8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96" y="752856"/>
            <a:ext cx="8217408" cy="5352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73781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/>
          <p:cNvSpPr txBox="1"/>
          <p:nvPr/>
        </p:nvSpPr>
        <p:spPr>
          <a:xfrm>
            <a:off x="251520" y="312911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8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005424"/>
            <a:ext cx="6918960" cy="4943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0780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4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5656" y="628104"/>
            <a:ext cx="5148634" cy="6185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1575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251520" y="312911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4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56" y="999744"/>
            <a:ext cx="9009888" cy="4858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6959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5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692696"/>
            <a:ext cx="7229856" cy="5718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02965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6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171" y="620688"/>
            <a:ext cx="7089648" cy="5687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34287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6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2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395" y="764704"/>
            <a:ext cx="8077200" cy="5742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5246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6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3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87" y="476672"/>
            <a:ext cx="8967216" cy="6010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52469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672" y="639530"/>
            <a:ext cx="5597616" cy="6023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87191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16632"/>
            <a:ext cx="36840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7 (uncropped gels and blots images)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67944" y="96898"/>
            <a:ext cx="962103" cy="307766"/>
          </a:xfrm>
          <a:prstGeom prst="rect">
            <a:avLst/>
          </a:prstGeom>
          <a:noFill/>
        </p:spPr>
        <p:txBody>
          <a:bodyPr wrap="none" lIns="91430" tIns="45715" rIns="91430" bIns="45715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-CO#2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712" y="620688"/>
            <a:ext cx="6132576" cy="5742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8475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</TotalTime>
  <Words>124</Words>
  <Application>Microsoft Office PowerPoint</Application>
  <PresentationFormat>화면 슬라이드 쇼(4:3)</PresentationFormat>
  <Paragraphs>20</Paragraphs>
  <Slides>1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1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NT</dc:creator>
  <cp:lastModifiedBy>SAMSUNG</cp:lastModifiedBy>
  <cp:revision>36</cp:revision>
  <dcterms:created xsi:type="dcterms:W3CDTF">2024-12-20T00:56:01Z</dcterms:created>
  <dcterms:modified xsi:type="dcterms:W3CDTF">2026-01-08T02:25:17Z</dcterms:modified>
</cp:coreProperties>
</file>